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7" r:id="rId2"/>
    <p:sldId id="287" r:id="rId3"/>
    <p:sldId id="288" r:id="rId4"/>
    <p:sldId id="28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6" userDrawn="1">
          <p15:clr>
            <a:srgbClr val="A4A3A4"/>
          </p15:clr>
        </p15:guide>
        <p15:guide id="2" pos="3864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B238D"/>
    <a:srgbClr val="00823B"/>
    <a:srgbClr val="FF3E11"/>
    <a:srgbClr val="7034DC"/>
    <a:srgbClr val="CF2DDB"/>
    <a:srgbClr val="009644"/>
    <a:srgbClr val="FF0000"/>
    <a:srgbClr val="0000FF"/>
    <a:srgbClr val="DC12D2"/>
    <a:srgbClr val="16CF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727996C-3E9A-476F-92BE-7B88FCB19D24}" v="15" dt="2023-01-16T11:28:00.655"/>
    <p1510:client id="{9F8DD977-68B0-471B-B782-C880DC65CBDD}" v="16" dt="2023-01-16T15:03:32.55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159" autoAdjust="0"/>
    <p:restoredTop sz="95878" autoAdjust="0"/>
  </p:normalViewPr>
  <p:slideViewPr>
    <p:cSldViewPr snapToGrid="0">
      <p:cViewPr varScale="1">
        <p:scale>
          <a:sx n="112" d="100"/>
          <a:sy n="112" d="100"/>
        </p:scale>
        <p:origin x="516" y="96"/>
      </p:cViewPr>
      <p:guideLst>
        <p:guide orient="horz" pos="2136"/>
        <p:guide pos="386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55" d="100"/>
          <a:sy n="55" d="100"/>
        </p:scale>
        <p:origin x="-2844" y="-10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akuru.vasu@outlook.com" userId="e87f3320efeb05aa" providerId="LiveId" clId="{9F8DD977-68B0-471B-B782-C880DC65CBDD}"/>
    <pc:docChg chg="undo custSel delSld modSld sldOrd">
      <pc:chgData name="bakuru.vasu@outlook.com" userId="e87f3320efeb05aa" providerId="LiveId" clId="{9F8DD977-68B0-471B-B782-C880DC65CBDD}" dt="2023-01-16T15:04:42.050" v="379"/>
      <pc:docMkLst>
        <pc:docMk/>
      </pc:docMkLst>
      <pc:sldChg chg="del">
        <pc:chgData name="bakuru.vasu@outlook.com" userId="e87f3320efeb05aa" providerId="LiveId" clId="{9F8DD977-68B0-471B-B782-C880DC65CBDD}" dt="2023-01-16T11:35:39.419" v="3" actId="47"/>
        <pc:sldMkLst>
          <pc:docMk/>
          <pc:sldMk cId="0" sldId="276"/>
        </pc:sldMkLst>
      </pc:sldChg>
      <pc:sldChg chg="delSp modSp mod">
        <pc:chgData name="bakuru.vasu@outlook.com" userId="e87f3320efeb05aa" providerId="LiveId" clId="{9F8DD977-68B0-471B-B782-C880DC65CBDD}" dt="2023-01-16T15:00:07.338" v="302" actId="20577"/>
        <pc:sldMkLst>
          <pc:docMk/>
          <pc:sldMk cId="0" sldId="277"/>
        </pc:sldMkLst>
        <pc:spChg chg="mod">
          <ac:chgData name="bakuru.vasu@outlook.com" userId="e87f3320efeb05aa" providerId="LiveId" clId="{9F8DD977-68B0-471B-B782-C880DC65CBDD}" dt="2023-01-16T15:00:07.338" v="302" actId="20577"/>
          <ac:spMkLst>
            <pc:docMk/>
            <pc:sldMk cId="0" sldId="277"/>
            <ac:spMk id="7" creationId="{00000000-0000-0000-0000-000000000000}"/>
          </ac:spMkLst>
        </pc:spChg>
        <pc:spChg chg="del">
          <ac:chgData name="bakuru.vasu@outlook.com" userId="e87f3320efeb05aa" providerId="LiveId" clId="{9F8DD977-68B0-471B-B782-C880DC65CBDD}" dt="2023-01-16T14:03:17.065" v="53" actId="478"/>
          <ac:spMkLst>
            <pc:docMk/>
            <pc:sldMk cId="0" sldId="277"/>
            <ac:spMk id="8" creationId="{00000000-0000-0000-0000-000000000000}"/>
          </ac:spMkLst>
        </pc:spChg>
        <pc:spChg chg="del mod">
          <ac:chgData name="bakuru.vasu@outlook.com" userId="e87f3320efeb05aa" providerId="LiveId" clId="{9F8DD977-68B0-471B-B782-C880DC65CBDD}" dt="2023-01-16T14:59:33.986" v="289" actId="478"/>
          <ac:spMkLst>
            <pc:docMk/>
            <pc:sldMk cId="0" sldId="277"/>
            <ac:spMk id="19" creationId="{B7AFD9DA-5FC0-466F-96FD-F57570995050}"/>
          </ac:spMkLst>
        </pc:spChg>
        <pc:spChg chg="mod">
          <ac:chgData name="bakuru.vasu@outlook.com" userId="e87f3320efeb05aa" providerId="LiveId" clId="{9F8DD977-68B0-471B-B782-C880DC65CBDD}" dt="2023-01-16T14:59:53.849" v="293" actId="1076"/>
          <ac:spMkLst>
            <pc:docMk/>
            <pc:sldMk cId="0" sldId="277"/>
            <ac:spMk id="27" creationId="{00000000-0000-0000-0000-000000000000}"/>
          </ac:spMkLst>
        </pc:spChg>
        <pc:grpChg chg="mod">
          <ac:chgData name="bakuru.vasu@outlook.com" userId="e87f3320efeb05aa" providerId="LiveId" clId="{9F8DD977-68B0-471B-B782-C880DC65CBDD}" dt="2023-01-16T14:59:44.889" v="292" actId="1076"/>
          <ac:grpSpMkLst>
            <pc:docMk/>
            <pc:sldMk cId="0" sldId="277"/>
            <ac:grpSpMk id="22" creationId="{00000000-0000-0000-0000-000000000000}"/>
          </ac:grpSpMkLst>
        </pc:grpChg>
      </pc:sldChg>
      <pc:sldChg chg="del">
        <pc:chgData name="bakuru.vasu@outlook.com" userId="e87f3320efeb05aa" providerId="LiveId" clId="{9F8DD977-68B0-471B-B782-C880DC65CBDD}" dt="2023-01-16T11:35:42.822" v="4" actId="47"/>
        <pc:sldMkLst>
          <pc:docMk/>
          <pc:sldMk cId="0" sldId="278"/>
        </pc:sldMkLst>
      </pc:sldChg>
      <pc:sldChg chg="del">
        <pc:chgData name="bakuru.vasu@outlook.com" userId="e87f3320efeb05aa" providerId="LiveId" clId="{9F8DD977-68B0-471B-B782-C880DC65CBDD}" dt="2023-01-16T11:35:49.746" v="5" actId="47"/>
        <pc:sldMkLst>
          <pc:docMk/>
          <pc:sldMk cId="0" sldId="279"/>
        </pc:sldMkLst>
      </pc:sldChg>
      <pc:sldChg chg="delSp modSp del mod">
        <pc:chgData name="bakuru.vasu@outlook.com" userId="e87f3320efeb05aa" providerId="LiveId" clId="{9F8DD977-68B0-471B-B782-C880DC65CBDD}" dt="2023-01-16T14:57:56.820" v="262" actId="47"/>
        <pc:sldMkLst>
          <pc:docMk/>
          <pc:sldMk cId="0" sldId="280"/>
        </pc:sldMkLst>
        <pc:spChg chg="mod">
          <ac:chgData name="bakuru.vasu@outlook.com" userId="e87f3320efeb05aa" providerId="LiveId" clId="{9F8DD977-68B0-471B-B782-C880DC65CBDD}" dt="2023-01-16T14:47:14.658" v="155" actId="1076"/>
          <ac:spMkLst>
            <pc:docMk/>
            <pc:sldMk cId="0" sldId="280"/>
            <ac:spMk id="7" creationId="{00000000-0000-0000-0000-000000000000}"/>
          </ac:spMkLst>
        </pc:spChg>
        <pc:spChg chg="mod">
          <ac:chgData name="bakuru.vasu@outlook.com" userId="e87f3320efeb05aa" providerId="LiveId" clId="{9F8DD977-68B0-471B-B782-C880DC65CBDD}" dt="2023-01-16T14:46:56.075" v="147" actId="1076"/>
          <ac:spMkLst>
            <pc:docMk/>
            <pc:sldMk cId="0" sldId="280"/>
            <ac:spMk id="13" creationId="{00000000-0000-0000-0000-000000000000}"/>
          </ac:spMkLst>
        </pc:spChg>
        <pc:grpChg chg="del">
          <ac:chgData name="bakuru.vasu@outlook.com" userId="e87f3320efeb05aa" providerId="LiveId" clId="{9F8DD977-68B0-471B-B782-C880DC65CBDD}" dt="2023-01-16T14:46:41.804" v="143" actId="478"/>
          <ac:grpSpMkLst>
            <pc:docMk/>
            <pc:sldMk cId="0" sldId="280"/>
            <ac:grpSpMk id="5" creationId="{00000000-0000-0000-0000-000000000000}"/>
          </ac:grpSpMkLst>
        </pc:grpChg>
        <pc:graphicFrameChg chg="mod">
          <ac:chgData name="bakuru.vasu@outlook.com" userId="e87f3320efeb05aa" providerId="LiveId" clId="{9F8DD977-68B0-471B-B782-C880DC65CBDD}" dt="2023-01-16T14:46:56.075" v="147" actId="1076"/>
          <ac:graphicFrameMkLst>
            <pc:docMk/>
            <pc:sldMk cId="0" sldId="280"/>
            <ac:graphicFrameMk id="11" creationId="{00000000-0000-0000-0000-000000000000}"/>
          </ac:graphicFrameMkLst>
        </pc:graphicFrameChg>
      </pc:sldChg>
      <pc:sldChg chg="addSp modSp mod">
        <pc:chgData name="bakuru.vasu@outlook.com" userId="e87f3320efeb05aa" providerId="LiveId" clId="{9F8DD977-68B0-471B-B782-C880DC65CBDD}" dt="2023-01-16T15:03:21.933" v="367" actId="58"/>
        <pc:sldMkLst>
          <pc:docMk/>
          <pc:sldMk cId="767066228" sldId="281"/>
        </pc:sldMkLst>
        <pc:spChg chg="add mod">
          <ac:chgData name="bakuru.vasu@outlook.com" userId="e87f3320efeb05aa" providerId="LiveId" clId="{9F8DD977-68B0-471B-B782-C880DC65CBDD}" dt="2023-01-16T14:58:55.417" v="285" actId="1076"/>
          <ac:spMkLst>
            <pc:docMk/>
            <pc:sldMk cId="767066228" sldId="281"/>
            <ac:spMk id="2" creationId="{E5F92A28-535E-4E0C-1BD2-97E3B457780D}"/>
          </ac:spMkLst>
        </pc:spChg>
        <pc:spChg chg="mod">
          <ac:chgData name="bakuru.vasu@outlook.com" userId="e87f3320efeb05aa" providerId="LiveId" clId="{9F8DD977-68B0-471B-B782-C880DC65CBDD}" dt="2023-01-16T14:58:20.546" v="263" actId="1076"/>
          <ac:spMkLst>
            <pc:docMk/>
            <pc:sldMk cId="767066228" sldId="281"/>
            <ac:spMk id="14" creationId="{D4FEC4CC-1837-C437-F956-12FC5C3606AC}"/>
          </ac:spMkLst>
        </pc:spChg>
        <pc:graphicFrameChg chg="mod modGraphic">
          <ac:chgData name="bakuru.vasu@outlook.com" userId="e87f3320efeb05aa" providerId="LiveId" clId="{9F8DD977-68B0-471B-B782-C880DC65CBDD}" dt="2023-01-16T15:03:21.933" v="367" actId="58"/>
          <ac:graphicFrameMkLst>
            <pc:docMk/>
            <pc:sldMk cId="767066228" sldId="281"/>
            <ac:graphicFrameMk id="4" creationId="{CCA365A3-9308-1BC7-4824-4E0EDE63C8E8}"/>
          </ac:graphicFrameMkLst>
        </pc:graphicFrameChg>
        <pc:picChg chg="mod">
          <ac:chgData name="bakuru.vasu@outlook.com" userId="e87f3320efeb05aa" providerId="LiveId" clId="{9F8DD977-68B0-471B-B782-C880DC65CBDD}" dt="2023-01-16T14:58:21.616" v="264" actId="1076"/>
          <ac:picMkLst>
            <pc:docMk/>
            <pc:sldMk cId="767066228" sldId="281"/>
            <ac:picMk id="16" creationId="{C0E24520-4668-2748-8077-529CB785963E}"/>
          </ac:picMkLst>
        </pc:picChg>
      </pc:sldChg>
      <pc:sldChg chg="delSp del mod">
        <pc:chgData name="bakuru.vasu@outlook.com" userId="e87f3320efeb05aa" providerId="LiveId" clId="{9F8DD977-68B0-471B-B782-C880DC65CBDD}" dt="2023-01-16T14:56:21.260" v="257" actId="47"/>
        <pc:sldMkLst>
          <pc:docMk/>
          <pc:sldMk cId="3305894811" sldId="282"/>
        </pc:sldMkLst>
        <pc:picChg chg="del">
          <ac:chgData name="bakuru.vasu@outlook.com" userId="e87f3320efeb05aa" providerId="LiveId" clId="{9F8DD977-68B0-471B-B782-C880DC65CBDD}" dt="2023-01-16T14:56:19.278" v="256" actId="478"/>
          <ac:picMkLst>
            <pc:docMk/>
            <pc:sldMk cId="3305894811" sldId="282"/>
            <ac:picMk id="5" creationId="{B602ECB5-794B-3EF3-B858-4A1747AF06F5}"/>
          </ac:picMkLst>
        </pc:picChg>
      </pc:sldChg>
      <pc:sldChg chg="addSp delSp modSp mod ord">
        <pc:chgData name="bakuru.vasu@outlook.com" userId="e87f3320efeb05aa" providerId="LiveId" clId="{9F8DD977-68B0-471B-B782-C880DC65CBDD}" dt="2023-01-16T15:04:42.050" v="379"/>
        <pc:sldMkLst>
          <pc:docMk/>
          <pc:sldMk cId="4207555519" sldId="283"/>
        </pc:sldMkLst>
        <pc:spChg chg="add mod">
          <ac:chgData name="bakuru.vasu@outlook.com" userId="e87f3320efeb05aa" providerId="LiveId" clId="{9F8DD977-68B0-471B-B782-C880DC65CBDD}" dt="2023-01-16T15:01:58.221" v="318" actId="1076"/>
          <ac:spMkLst>
            <pc:docMk/>
            <pc:sldMk cId="4207555519" sldId="283"/>
            <ac:spMk id="2" creationId="{A5C94223-F22D-B4DF-1863-CA2A127BB798}"/>
          </ac:spMkLst>
        </pc:spChg>
        <pc:spChg chg="add del mod">
          <ac:chgData name="bakuru.vasu@outlook.com" userId="e87f3320efeb05aa" providerId="LiveId" clId="{9F8DD977-68B0-471B-B782-C880DC65CBDD}" dt="2023-01-16T15:03:12.344" v="366" actId="1076"/>
          <ac:spMkLst>
            <pc:docMk/>
            <pc:sldMk cId="4207555519" sldId="283"/>
            <ac:spMk id="4" creationId="{168E9F69-8B87-4704-D405-98B38033B1D4}"/>
          </ac:spMkLst>
        </pc:spChg>
        <pc:picChg chg="mod">
          <ac:chgData name="bakuru.vasu@outlook.com" userId="e87f3320efeb05aa" providerId="LiveId" clId="{9F8DD977-68B0-471B-B782-C880DC65CBDD}" dt="2023-01-16T15:03:26.161" v="368" actId="1076"/>
          <ac:picMkLst>
            <pc:docMk/>
            <pc:sldMk cId="4207555519" sldId="283"/>
            <ac:picMk id="3" creationId="{785D5C0D-C342-BE74-49BB-8DCA1B24B6E6}"/>
          </ac:picMkLst>
        </pc:picChg>
      </pc:sldChg>
      <pc:sldChg chg="addSp delSp modSp mod">
        <pc:chgData name="bakuru.vasu@outlook.com" userId="e87f3320efeb05aa" providerId="LiveId" clId="{9F8DD977-68B0-471B-B782-C880DC65CBDD}" dt="2023-01-16T15:03:46.617" v="377" actId="1076"/>
        <pc:sldMkLst>
          <pc:docMk/>
          <pc:sldMk cId="2889419637" sldId="284"/>
        </pc:sldMkLst>
        <pc:spChg chg="add mod">
          <ac:chgData name="bakuru.vasu@outlook.com" userId="e87f3320efeb05aa" providerId="LiveId" clId="{9F8DD977-68B0-471B-B782-C880DC65CBDD}" dt="2023-01-16T15:03:46.617" v="377" actId="1076"/>
          <ac:spMkLst>
            <pc:docMk/>
            <pc:sldMk cId="2889419637" sldId="284"/>
            <ac:spMk id="3" creationId="{1A386D90-8B2C-B398-5C2D-4C022AD4B2D2}"/>
          </ac:spMkLst>
        </pc:spChg>
        <pc:spChg chg="del">
          <ac:chgData name="bakuru.vasu@outlook.com" userId="e87f3320efeb05aa" providerId="LiveId" clId="{9F8DD977-68B0-471B-B782-C880DC65CBDD}" dt="2023-01-16T15:03:01.119" v="363" actId="478"/>
          <ac:spMkLst>
            <pc:docMk/>
            <pc:sldMk cId="2889419637" sldId="284"/>
            <ac:spMk id="4" creationId="{04A18820-EF41-3D61-B633-035D697324FE}"/>
          </ac:spMkLst>
        </pc:spChg>
        <pc:spChg chg="add mod">
          <ac:chgData name="bakuru.vasu@outlook.com" userId="e87f3320efeb05aa" providerId="LiveId" clId="{9F8DD977-68B0-471B-B782-C880DC65CBDD}" dt="2023-01-16T15:03:42.004" v="375" actId="58"/>
          <ac:spMkLst>
            <pc:docMk/>
            <pc:sldMk cId="2889419637" sldId="284"/>
            <ac:spMk id="5" creationId="{6D8D9134-A743-84D1-D6E1-52D09CC06AD6}"/>
          </ac:spMkLst>
        </pc:spChg>
        <pc:picChg chg="mod">
          <ac:chgData name="bakuru.vasu@outlook.com" userId="e87f3320efeb05aa" providerId="LiveId" clId="{9F8DD977-68B0-471B-B782-C880DC65CBDD}" dt="2023-01-16T15:03:44.416" v="376" actId="1076"/>
          <ac:picMkLst>
            <pc:docMk/>
            <pc:sldMk cId="2889419637" sldId="284"/>
            <ac:picMk id="2" creationId="{D571683E-3DF8-E59F-AA79-C82AB285D0A0}"/>
          </ac:picMkLst>
        </pc:picChg>
      </pc:sldChg>
      <pc:sldChg chg="modSp del mod">
        <pc:chgData name="bakuru.vasu@outlook.com" userId="e87f3320efeb05aa" providerId="LiveId" clId="{9F8DD977-68B0-471B-B782-C880DC65CBDD}" dt="2023-01-16T15:01:15.560" v="303" actId="47"/>
        <pc:sldMkLst>
          <pc:docMk/>
          <pc:sldMk cId="3069306753" sldId="285"/>
        </pc:sldMkLst>
        <pc:spChg chg="mod">
          <ac:chgData name="bakuru.vasu@outlook.com" userId="e87f3320efeb05aa" providerId="LiveId" clId="{9F8DD977-68B0-471B-B782-C880DC65CBDD}" dt="2023-01-16T14:57:06.689" v="261" actId="1076"/>
          <ac:spMkLst>
            <pc:docMk/>
            <pc:sldMk cId="3069306753" sldId="285"/>
            <ac:spMk id="4" creationId="{5EF40A8D-4D51-A3F7-0CBB-4661FC6A052A}"/>
          </ac:spMkLst>
        </pc:spChg>
      </pc:sldChg>
      <pc:sldChg chg="addSp delSp modSp del mod">
        <pc:chgData name="bakuru.vasu@outlook.com" userId="e87f3320efeb05aa" providerId="LiveId" clId="{9F8DD977-68B0-471B-B782-C880DC65CBDD}" dt="2023-01-16T14:05:07.468" v="72" actId="47"/>
        <pc:sldMkLst>
          <pc:docMk/>
          <pc:sldMk cId="2548721347" sldId="286"/>
        </pc:sldMkLst>
        <pc:spChg chg="mod">
          <ac:chgData name="bakuru.vasu@outlook.com" userId="e87f3320efeb05aa" providerId="LiveId" clId="{9F8DD977-68B0-471B-B782-C880DC65CBDD}" dt="2023-01-16T14:02:06.859" v="40" actId="1076"/>
          <ac:spMkLst>
            <pc:docMk/>
            <pc:sldMk cId="2548721347" sldId="286"/>
            <ac:spMk id="3" creationId="{4F4DCD22-051A-644A-BB9E-803E5D792A06}"/>
          </ac:spMkLst>
        </pc:spChg>
        <pc:picChg chg="add del mod">
          <ac:chgData name="bakuru.vasu@outlook.com" userId="e87f3320efeb05aa" providerId="LiveId" clId="{9F8DD977-68B0-471B-B782-C880DC65CBDD}" dt="2023-01-16T14:02:11.194" v="42" actId="1076"/>
          <ac:picMkLst>
            <pc:docMk/>
            <pc:sldMk cId="2548721347" sldId="286"/>
            <ac:picMk id="2" creationId="{E291384F-00DC-E471-BFA6-FBD8C4FC8F35}"/>
          </ac:picMkLst>
        </pc:picChg>
      </pc:sldChg>
      <pc:sldChg chg="addSp delSp modSp mod">
        <pc:chgData name="bakuru.vasu@outlook.com" userId="e87f3320efeb05aa" providerId="LiveId" clId="{9F8DD977-68B0-471B-B782-C880DC65CBDD}" dt="2023-01-16T14:59:00.012" v="287" actId="114"/>
        <pc:sldMkLst>
          <pc:docMk/>
          <pc:sldMk cId="3883074255" sldId="287"/>
        </pc:sldMkLst>
        <pc:spChg chg="add mod">
          <ac:chgData name="bakuru.vasu@outlook.com" userId="e87f3320efeb05aa" providerId="LiveId" clId="{9F8DD977-68B0-471B-B782-C880DC65CBDD}" dt="2023-01-16T14:59:00.012" v="287" actId="114"/>
          <ac:spMkLst>
            <pc:docMk/>
            <pc:sldMk cId="3883074255" sldId="287"/>
            <ac:spMk id="10" creationId="{D079C04F-950A-7191-2D27-7E9E36258C9D}"/>
          </ac:spMkLst>
        </pc:spChg>
        <pc:spChg chg="add del mod">
          <ac:chgData name="bakuru.vasu@outlook.com" userId="e87f3320efeb05aa" providerId="LiveId" clId="{9F8DD977-68B0-471B-B782-C880DC65CBDD}" dt="2023-01-16T14:48:59.237" v="179" actId="478"/>
          <ac:spMkLst>
            <pc:docMk/>
            <pc:sldMk cId="3883074255" sldId="287"/>
            <ac:spMk id="11" creationId="{8A40B78D-950D-ABD5-0027-8C2143F4801C}"/>
          </ac:spMkLst>
        </pc:spChg>
        <pc:spChg chg="add mod">
          <ac:chgData name="bakuru.vasu@outlook.com" userId="e87f3320efeb05aa" providerId="LiveId" clId="{9F8DD977-68B0-471B-B782-C880DC65CBDD}" dt="2023-01-16T14:52:07.505" v="251" actId="1076"/>
          <ac:spMkLst>
            <pc:docMk/>
            <pc:sldMk cId="3883074255" sldId="287"/>
            <ac:spMk id="12" creationId="{203EBA80-B30F-3964-EA1B-860EC2B3AD7A}"/>
          </ac:spMkLst>
        </pc:spChg>
        <pc:graphicFrameChg chg="mod modGraphic">
          <ac:chgData name="bakuru.vasu@outlook.com" userId="e87f3320efeb05aa" providerId="LiveId" clId="{9F8DD977-68B0-471B-B782-C880DC65CBDD}" dt="2023-01-16T14:47:24.577" v="159" actId="1076"/>
          <ac:graphicFrameMkLst>
            <pc:docMk/>
            <pc:sldMk cId="3883074255" sldId="287"/>
            <ac:graphicFrameMk id="2" creationId="{02CC9FBF-5487-024E-375F-4AAE3CE36FB2}"/>
          </ac:graphicFrameMkLst>
        </pc:graphicFrameChg>
        <pc:picChg chg="add del mod modCrop">
          <ac:chgData name="bakuru.vasu@outlook.com" userId="e87f3320efeb05aa" providerId="LiveId" clId="{9F8DD977-68B0-471B-B782-C880DC65CBDD}" dt="2023-01-16T13:59:19.799" v="25" actId="478"/>
          <ac:picMkLst>
            <pc:docMk/>
            <pc:sldMk cId="3883074255" sldId="287"/>
            <ac:picMk id="4" creationId="{D76EECBE-3847-0AC1-C924-E8F8F1B03AE9}"/>
          </ac:picMkLst>
        </pc:picChg>
        <pc:picChg chg="add del mod modCrop">
          <ac:chgData name="bakuru.vasu@outlook.com" userId="e87f3320efeb05aa" providerId="LiveId" clId="{9F8DD977-68B0-471B-B782-C880DC65CBDD}" dt="2023-01-16T14:02:19.025" v="45" actId="478"/>
          <ac:picMkLst>
            <pc:docMk/>
            <pc:sldMk cId="3883074255" sldId="287"/>
            <ac:picMk id="6" creationId="{1E3C5374-F228-DD01-76EF-DF12B0B9F8DB}"/>
          </ac:picMkLst>
        </pc:picChg>
        <pc:picChg chg="add del mod">
          <ac:chgData name="bakuru.vasu@outlook.com" userId="e87f3320efeb05aa" providerId="LiveId" clId="{9F8DD977-68B0-471B-B782-C880DC65CBDD}" dt="2023-01-16T14:19:26.025" v="98" actId="478"/>
          <ac:picMkLst>
            <pc:docMk/>
            <pc:sldMk cId="3883074255" sldId="287"/>
            <ac:picMk id="7" creationId="{26904ECC-5051-3A59-3D89-981C155E6F32}"/>
          </ac:picMkLst>
        </pc:picChg>
        <pc:picChg chg="add mod modCrop">
          <ac:chgData name="bakuru.vasu@outlook.com" userId="e87f3320efeb05aa" providerId="LiveId" clId="{9F8DD977-68B0-471B-B782-C880DC65CBDD}" dt="2023-01-16T14:47:40.189" v="163" actId="1076"/>
          <ac:picMkLst>
            <pc:docMk/>
            <pc:sldMk cId="3883074255" sldId="287"/>
            <ac:picMk id="9" creationId="{8F2C38E1-DE23-9AA7-6A03-85261C21CD4F}"/>
          </ac:picMkLst>
        </pc:picChg>
      </pc:sldChg>
      <pc:sldChg chg="addSp delSp modSp mod">
        <pc:chgData name="bakuru.vasu@outlook.com" userId="e87f3320efeb05aa" providerId="LiveId" clId="{9F8DD977-68B0-471B-B782-C880DC65CBDD}" dt="2023-01-16T14:52:20.327" v="255" actId="20577"/>
        <pc:sldMkLst>
          <pc:docMk/>
          <pc:sldMk cId="2227354023" sldId="288"/>
        </pc:sldMkLst>
        <pc:spChg chg="add del mod">
          <ac:chgData name="bakuru.vasu@outlook.com" userId="e87f3320efeb05aa" providerId="LiveId" clId="{9F8DD977-68B0-471B-B782-C880DC65CBDD}" dt="2023-01-16T14:50:57.726" v="202" actId="478"/>
          <ac:spMkLst>
            <pc:docMk/>
            <pc:sldMk cId="2227354023" sldId="288"/>
            <ac:spMk id="5" creationId="{F6558665-3CEA-A597-C9E0-CEF66C7E4790}"/>
          </ac:spMkLst>
        </pc:spChg>
        <pc:spChg chg="add del mod">
          <ac:chgData name="bakuru.vasu@outlook.com" userId="e87f3320efeb05aa" providerId="LiveId" clId="{9F8DD977-68B0-471B-B782-C880DC65CBDD}" dt="2023-01-16T14:52:16.050" v="252" actId="478"/>
          <ac:spMkLst>
            <pc:docMk/>
            <pc:sldMk cId="2227354023" sldId="288"/>
            <ac:spMk id="6" creationId="{C61C05D9-84D3-3997-C162-C28C5010C3FE}"/>
          </ac:spMkLst>
        </pc:spChg>
        <pc:spChg chg="add mod">
          <ac:chgData name="bakuru.vasu@outlook.com" userId="e87f3320efeb05aa" providerId="LiveId" clId="{9F8DD977-68B0-471B-B782-C880DC65CBDD}" dt="2023-01-16T14:52:20.327" v="255" actId="20577"/>
          <ac:spMkLst>
            <pc:docMk/>
            <pc:sldMk cId="2227354023" sldId="288"/>
            <ac:spMk id="7" creationId="{A93A04ED-ECAA-D54D-3105-FD8AAC58C003}"/>
          </ac:spMkLst>
        </pc:spChg>
        <pc:graphicFrameChg chg="add mod modGraphic">
          <ac:chgData name="bakuru.vasu@outlook.com" userId="e87f3320efeb05aa" providerId="LiveId" clId="{9F8DD977-68B0-471B-B782-C880DC65CBDD}" dt="2023-01-16T14:27:33.040" v="137" actId="20577"/>
          <ac:graphicFrameMkLst>
            <pc:docMk/>
            <pc:sldMk cId="2227354023" sldId="288"/>
            <ac:graphicFrameMk id="4" creationId="{C164A676-A4CC-2E2F-5E46-1B42C1E7EA74}"/>
          </ac:graphicFrameMkLst>
        </pc:graphicFrameChg>
        <pc:picChg chg="add mod modCrop">
          <ac:chgData name="bakuru.vasu@outlook.com" userId="e87f3320efeb05aa" providerId="LiveId" clId="{9F8DD977-68B0-471B-B782-C880DC65CBDD}" dt="2023-01-16T14:43:26.889" v="142" actId="1076"/>
          <ac:picMkLst>
            <pc:docMk/>
            <pc:sldMk cId="2227354023" sldId="288"/>
            <ac:picMk id="3" creationId="{3D9FA295-7C05-9A28-2D81-B367CB9B48EA}"/>
          </ac:picMkLst>
        </pc:picChg>
      </pc:sldChg>
    </pc:docChg>
  </pc:docChgLst>
  <pc:docChgLst>
    <pc:chgData name="bakuru.vasu@outlook.com" userId="e87f3320efeb05aa" providerId="LiveId" clId="{3E8852AF-14FB-4EB8-B25A-F43A072BB063}"/>
    <pc:docChg chg="undo custSel addSld modSld">
      <pc:chgData name="bakuru.vasu@outlook.com" userId="e87f3320efeb05aa" providerId="LiveId" clId="{3E8852AF-14FB-4EB8-B25A-F43A072BB063}" dt="2022-11-12T22:03:36.986" v="248" actId="1076"/>
      <pc:docMkLst>
        <pc:docMk/>
      </pc:docMkLst>
      <pc:sldChg chg="modSp mod">
        <pc:chgData name="bakuru.vasu@outlook.com" userId="e87f3320efeb05aa" providerId="LiveId" clId="{3E8852AF-14FB-4EB8-B25A-F43A072BB063}" dt="2022-11-12T18:46:12.910" v="2" actId="33524"/>
        <pc:sldMkLst>
          <pc:docMk/>
          <pc:sldMk cId="0" sldId="277"/>
        </pc:sldMkLst>
        <pc:spChg chg="mod">
          <ac:chgData name="bakuru.vasu@outlook.com" userId="e87f3320efeb05aa" providerId="LiveId" clId="{3E8852AF-14FB-4EB8-B25A-F43A072BB063}" dt="2022-11-12T18:46:12.910" v="2" actId="33524"/>
          <ac:spMkLst>
            <pc:docMk/>
            <pc:sldMk cId="0" sldId="277"/>
            <ac:spMk id="7" creationId="{00000000-0000-0000-0000-000000000000}"/>
          </ac:spMkLst>
        </pc:spChg>
        <pc:grpChg chg="mod">
          <ac:chgData name="bakuru.vasu@outlook.com" userId="e87f3320efeb05aa" providerId="LiveId" clId="{3E8852AF-14FB-4EB8-B25A-F43A072BB063}" dt="2022-11-12T13:31:58.796" v="0" actId="1076"/>
          <ac:grpSpMkLst>
            <pc:docMk/>
            <pc:sldMk cId="0" sldId="277"/>
            <ac:grpSpMk id="22" creationId="{00000000-0000-0000-0000-000000000000}"/>
          </ac:grpSpMkLst>
        </pc:grpChg>
      </pc:sldChg>
      <pc:sldChg chg="modSp mod">
        <pc:chgData name="bakuru.vasu@outlook.com" userId="e87f3320efeb05aa" providerId="LiveId" clId="{3E8852AF-14FB-4EB8-B25A-F43A072BB063}" dt="2022-11-12T14:12:01.814" v="1" actId="14100"/>
        <pc:sldMkLst>
          <pc:docMk/>
          <pc:sldMk cId="0" sldId="280"/>
        </pc:sldMkLst>
        <pc:spChg chg="mod">
          <ac:chgData name="bakuru.vasu@outlook.com" userId="e87f3320efeb05aa" providerId="LiveId" clId="{3E8852AF-14FB-4EB8-B25A-F43A072BB063}" dt="2022-11-12T14:12:01.814" v="1" actId="14100"/>
          <ac:spMkLst>
            <pc:docMk/>
            <pc:sldMk cId="0" sldId="280"/>
            <ac:spMk id="7" creationId="{00000000-0000-0000-0000-000000000000}"/>
          </ac:spMkLst>
        </pc:spChg>
      </pc:sldChg>
      <pc:sldChg chg="addSp delSp modSp new mod">
        <pc:chgData name="bakuru.vasu@outlook.com" userId="e87f3320efeb05aa" providerId="LiveId" clId="{3E8852AF-14FB-4EB8-B25A-F43A072BB063}" dt="2022-11-12T22:03:36.986" v="248" actId="1076"/>
        <pc:sldMkLst>
          <pc:docMk/>
          <pc:sldMk cId="767066228" sldId="281"/>
        </pc:sldMkLst>
        <pc:spChg chg="del">
          <ac:chgData name="bakuru.vasu@outlook.com" userId="e87f3320efeb05aa" providerId="LiveId" clId="{3E8852AF-14FB-4EB8-B25A-F43A072BB063}" dt="2022-11-12T19:51:05.203" v="4" actId="478"/>
          <ac:spMkLst>
            <pc:docMk/>
            <pc:sldMk cId="767066228" sldId="281"/>
            <ac:spMk id="2" creationId="{5F3CC04C-B5EC-AE82-F775-D54EED720B4A}"/>
          </ac:spMkLst>
        </pc:spChg>
        <pc:spChg chg="del">
          <ac:chgData name="bakuru.vasu@outlook.com" userId="e87f3320efeb05aa" providerId="LiveId" clId="{3E8852AF-14FB-4EB8-B25A-F43A072BB063}" dt="2022-11-12T19:51:05.203" v="4" actId="478"/>
          <ac:spMkLst>
            <pc:docMk/>
            <pc:sldMk cId="767066228" sldId="281"/>
            <ac:spMk id="3" creationId="{6D2F4C00-C868-DE60-BF75-535827837253}"/>
          </ac:spMkLst>
        </pc:spChg>
        <pc:spChg chg="add del mod">
          <ac:chgData name="bakuru.vasu@outlook.com" userId="e87f3320efeb05aa" providerId="LiveId" clId="{3E8852AF-14FB-4EB8-B25A-F43A072BB063}" dt="2022-11-12T20:58:16.061" v="199" actId="478"/>
          <ac:spMkLst>
            <pc:docMk/>
            <pc:sldMk cId="767066228" sldId="281"/>
            <ac:spMk id="8" creationId="{29EAE71E-34DE-F203-D6B2-66CA2AE8EA2A}"/>
          </ac:spMkLst>
        </pc:spChg>
        <pc:spChg chg="add del mod">
          <ac:chgData name="bakuru.vasu@outlook.com" userId="e87f3320efeb05aa" providerId="LiveId" clId="{3E8852AF-14FB-4EB8-B25A-F43A072BB063}" dt="2022-11-12T20:58:14.952" v="198" actId="478"/>
          <ac:spMkLst>
            <pc:docMk/>
            <pc:sldMk cId="767066228" sldId="281"/>
            <ac:spMk id="13" creationId="{44B531CA-C15D-7789-DB71-28A93B928903}"/>
          </ac:spMkLst>
        </pc:spChg>
        <pc:spChg chg="add mod">
          <ac:chgData name="bakuru.vasu@outlook.com" userId="e87f3320efeb05aa" providerId="LiveId" clId="{3E8852AF-14FB-4EB8-B25A-F43A072BB063}" dt="2022-11-12T22:03:36.986" v="248" actId="1076"/>
          <ac:spMkLst>
            <pc:docMk/>
            <pc:sldMk cId="767066228" sldId="281"/>
            <ac:spMk id="14" creationId="{D4FEC4CC-1837-C437-F956-12FC5C3606AC}"/>
          </ac:spMkLst>
        </pc:spChg>
        <pc:graphicFrameChg chg="add mod modGraphic">
          <ac:chgData name="bakuru.vasu@outlook.com" userId="e87f3320efeb05aa" providerId="LiveId" clId="{3E8852AF-14FB-4EB8-B25A-F43A072BB063}" dt="2022-11-12T22:03:03.658" v="237" actId="1076"/>
          <ac:graphicFrameMkLst>
            <pc:docMk/>
            <pc:sldMk cId="767066228" sldId="281"/>
            <ac:graphicFrameMk id="4" creationId="{CCA365A3-9308-1BC7-4824-4E0EDE63C8E8}"/>
          </ac:graphicFrameMkLst>
        </pc:graphicFrameChg>
        <pc:graphicFrameChg chg="add del mod modGraphic">
          <ac:chgData name="bakuru.vasu@outlook.com" userId="e87f3320efeb05aa" providerId="LiveId" clId="{3E8852AF-14FB-4EB8-B25A-F43A072BB063}" dt="2022-11-12T20:20:52.581" v="124" actId="478"/>
          <ac:graphicFrameMkLst>
            <pc:docMk/>
            <pc:sldMk cId="767066228" sldId="281"/>
            <ac:graphicFrameMk id="5" creationId="{BAF21EF2-3893-A782-1514-0D74B785F690}"/>
          </ac:graphicFrameMkLst>
        </pc:graphicFrameChg>
        <pc:picChg chg="add del mod">
          <ac:chgData name="bakuru.vasu@outlook.com" userId="e87f3320efeb05aa" providerId="LiveId" clId="{3E8852AF-14FB-4EB8-B25A-F43A072BB063}" dt="2022-11-12T20:41:27.577" v="169" actId="478"/>
          <ac:picMkLst>
            <pc:docMk/>
            <pc:sldMk cId="767066228" sldId="281"/>
            <ac:picMk id="7" creationId="{6592C4AF-51C0-C984-3E3B-E080F119BB5D}"/>
          </ac:picMkLst>
        </pc:picChg>
        <pc:picChg chg="add del mod">
          <ac:chgData name="bakuru.vasu@outlook.com" userId="e87f3320efeb05aa" providerId="LiveId" clId="{3E8852AF-14FB-4EB8-B25A-F43A072BB063}" dt="2022-11-12T20:58:14.100" v="197" actId="478"/>
          <ac:picMkLst>
            <pc:docMk/>
            <pc:sldMk cId="767066228" sldId="281"/>
            <ac:picMk id="10" creationId="{1ACAFAC0-D318-2B80-0D58-42D555D9D888}"/>
          </ac:picMkLst>
        </pc:picChg>
        <pc:picChg chg="add del mod">
          <ac:chgData name="bakuru.vasu@outlook.com" userId="e87f3320efeb05aa" providerId="LiveId" clId="{3E8852AF-14FB-4EB8-B25A-F43A072BB063}" dt="2022-11-12T20:58:13.406" v="196" actId="478"/>
          <ac:picMkLst>
            <pc:docMk/>
            <pc:sldMk cId="767066228" sldId="281"/>
            <ac:picMk id="12" creationId="{95C50CAE-82C6-FD8C-DD4C-7DEAAA0FA30B}"/>
          </ac:picMkLst>
        </pc:picChg>
        <pc:picChg chg="add mod modCrop">
          <ac:chgData name="bakuru.vasu@outlook.com" userId="e87f3320efeb05aa" providerId="LiveId" clId="{3E8852AF-14FB-4EB8-B25A-F43A072BB063}" dt="2022-11-12T22:03:05.254" v="238" actId="1076"/>
          <ac:picMkLst>
            <pc:docMk/>
            <pc:sldMk cId="767066228" sldId="281"/>
            <ac:picMk id="16" creationId="{C0E24520-4668-2748-8077-529CB785963E}"/>
          </ac:picMkLst>
        </pc:picChg>
      </pc:sldChg>
    </pc:docChg>
  </pc:docChgLst>
  <pc:docChgLst>
    <pc:chgData name="bakuru.vasu@outlook.com" userId="e87f3320efeb05aa" providerId="LiveId" clId="{25A941F8-F20A-42C9-980C-7EC37038D852}"/>
    <pc:docChg chg="custSel addSld modSld">
      <pc:chgData name="bakuru.vasu@outlook.com" userId="e87f3320efeb05aa" providerId="LiveId" clId="{25A941F8-F20A-42C9-980C-7EC37038D852}" dt="2022-12-08T20:46:27.578" v="14" actId="1076"/>
      <pc:docMkLst>
        <pc:docMk/>
      </pc:docMkLst>
      <pc:sldChg chg="modSp mod">
        <pc:chgData name="bakuru.vasu@outlook.com" userId="e87f3320efeb05aa" providerId="LiveId" clId="{25A941F8-F20A-42C9-980C-7EC37038D852}" dt="2022-11-27T15:32:59.997" v="0" actId="1076"/>
        <pc:sldMkLst>
          <pc:docMk/>
          <pc:sldMk cId="0" sldId="276"/>
        </pc:sldMkLst>
        <pc:spChg chg="mod">
          <ac:chgData name="bakuru.vasu@outlook.com" userId="e87f3320efeb05aa" providerId="LiveId" clId="{25A941F8-F20A-42C9-980C-7EC37038D852}" dt="2022-11-27T15:32:59.997" v="0" actId="1076"/>
          <ac:spMkLst>
            <pc:docMk/>
            <pc:sldMk cId="0" sldId="276"/>
            <ac:spMk id="13" creationId="{00000000-0000-0000-0000-000000000000}"/>
          </ac:spMkLst>
        </pc:spChg>
      </pc:sldChg>
      <pc:sldChg chg="addSp delSp modSp new mod">
        <pc:chgData name="bakuru.vasu@outlook.com" userId="e87f3320efeb05aa" providerId="LiveId" clId="{25A941F8-F20A-42C9-980C-7EC37038D852}" dt="2022-12-08T20:40:53.560" v="9" actId="1076"/>
        <pc:sldMkLst>
          <pc:docMk/>
          <pc:sldMk cId="3305894811" sldId="282"/>
        </pc:sldMkLst>
        <pc:spChg chg="add del">
          <ac:chgData name="bakuru.vasu@outlook.com" userId="e87f3320efeb05aa" providerId="LiveId" clId="{25A941F8-F20A-42C9-980C-7EC37038D852}" dt="2022-12-08T20:40:38.506" v="3" actId="478"/>
          <ac:spMkLst>
            <pc:docMk/>
            <pc:sldMk cId="3305894811" sldId="282"/>
            <ac:spMk id="3" creationId="{6C7E2344-B7B1-B392-705F-6A1DFA045E90}"/>
          </ac:spMkLst>
        </pc:spChg>
        <pc:picChg chg="add mod">
          <ac:chgData name="bakuru.vasu@outlook.com" userId="e87f3320efeb05aa" providerId="LiveId" clId="{25A941F8-F20A-42C9-980C-7EC37038D852}" dt="2022-12-08T20:40:53.560" v="9" actId="1076"/>
          <ac:picMkLst>
            <pc:docMk/>
            <pc:sldMk cId="3305894811" sldId="282"/>
            <ac:picMk id="5" creationId="{B602ECB5-794B-3EF3-B858-4A1747AF06F5}"/>
          </ac:picMkLst>
        </pc:picChg>
      </pc:sldChg>
      <pc:sldChg chg="addSp modSp new mod">
        <pc:chgData name="bakuru.vasu@outlook.com" userId="e87f3320efeb05aa" providerId="LiveId" clId="{25A941F8-F20A-42C9-980C-7EC37038D852}" dt="2022-12-08T20:46:27.578" v="14" actId="1076"/>
        <pc:sldMkLst>
          <pc:docMk/>
          <pc:sldMk cId="4207555519" sldId="283"/>
        </pc:sldMkLst>
        <pc:picChg chg="add mod">
          <ac:chgData name="bakuru.vasu@outlook.com" userId="e87f3320efeb05aa" providerId="LiveId" clId="{25A941F8-F20A-42C9-980C-7EC37038D852}" dt="2022-12-08T20:46:27.578" v="14" actId="1076"/>
          <ac:picMkLst>
            <pc:docMk/>
            <pc:sldMk cId="4207555519" sldId="283"/>
            <ac:picMk id="3" creationId="{785D5C0D-C342-BE74-49BB-8DCA1B24B6E6}"/>
          </ac:picMkLst>
        </pc:picChg>
      </pc:sldChg>
    </pc:docChg>
  </pc:docChgLst>
  <pc:docChgLst>
    <pc:chgData name="bakuru.vasu@outlook.com" userId="e87f3320efeb05aa" providerId="LiveId" clId="{5727996C-3E9A-476F-92BE-7B88FCB19D24}"/>
    <pc:docChg chg="undo custSel addSld modSld sldOrd">
      <pc:chgData name="bakuru.vasu@outlook.com" userId="e87f3320efeb05aa" providerId="LiveId" clId="{5727996C-3E9A-476F-92BE-7B88FCB19D24}" dt="2023-01-16T11:28:01.051" v="218" actId="1076"/>
      <pc:docMkLst>
        <pc:docMk/>
      </pc:docMkLst>
      <pc:sldChg chg="modSp mod">
        <pc:chgData name="bakuru.vasu@outlook.com" userId="e87f3320efeb05aa" providerId="LiveId" clId="{5727996C-3E9A-476F-92BE-7B88FCB19D24}" dt="2023-01-16T09:16:18.347" v="194" actId="33524"/>
        <pc:sldMkLst>
          <pc:docMk/>
          <pc:sldMk cId="0" sldId="277"/>
        </pc:sldMkLst>
        <pc:spChg chg="mod">
          <ac:chgData name="bakuru.vasu@outlook.com" userId="e87f3320efeb05aa" providerId="LiveId" clId="{5727996C-3E9A-476F-92BE-7B88FCB19D24}" dt="2023-01-16T09:16:18.347" v="194" actId="33524"/>
          <ac:spMkLst>
            <pc:docMk/>
            <pc:sldMk cId="0" sldId="277"/>
            <ac:spMk id="19" creationId="{B7AFD9DA-5FC0-466F-96FD-F57570995050}"/>
          </ac:spMkLst>
        </pc:spChg>
        <pc:grpChg chg="mod">
          <ac:chgData name="bakuru.vasu@outlook.com" userId="e87f3320efeb05aa" providerId="LiveId" clId="{5727996C-3E9A-476F-92BE-7B88FCB19D24}" dt="2023-01-12T05:45:46.379" v="162" actId="1076"/>
          <ac:grpSpMkLst>
            <pc:docMk/>
            <pc:sldMk cId="0" sldId="277"/>
            <ac:grpSpMk id="22" creationId="{00000000-0000-0000-0000-000000000000}"/>
          </ac:grpSpMkLst>
        </pc:grpChg>
        <pc:grpChg chg="mod">
          <ac:chgData name="bakuru.vasu@outlook.com" userId="e87f3320efeb05aa" providerId="LiveId" clId="{5727996C-3E9A-476F-92BE-7B88FCB19D24}" dt="2023-01-12T05:47:55.202" v="165" actId="1076"/>
          <ac:grpSpMkLst>
            <pc:docMk/>
            <pc:sldMk cId="0" sldId="277"/>
            <ac:grpSpMk id="28" creationId="{00000000-0000-0000-0000-000000000000}"/>
          </ac:grpSpMkLst>
        </pc:grpChg>
      </pc:sldChg>
      <pc:sldChg chg="addSp delSp modSp mod">
        <pc:chgData name="bakuru.vasu@outlook.com" userId="e87f3320efeb05aa" providerId="LiveId" clId="{5727996C-3E9A-476F-92BE-7B88FCB19D24}" dt="2023-01-13T10:52:30.844" v="166" actId="1076"/>
        <pc:sldMkLst>
          <pc:docMk/>
          <pc:sldMk cId="0" sldId="280"/>
        </pc:sldMkLst>
        <pc:graphicFrameChg chg="add del mod">
          <ac:chgData name="bakuru.vasu@outlook.com" userId="e87f3320efeb05aa" providerId="LiveId" clId="{5727996C-3E9A-476F-92BE-7B88FCB19D24}" dt="2023-01-12T05:25:41.054" v="124"/>
          <ac:graphicFrameMkLst>
            <pc:docMk/>
            <pc:sldMk cId="0" sldId="280"/>
            <ac:graphicFrameMk id="2" creationId="{2D3ACD98-49AF-7443-0745-E4F196F180DB}"/>
          </ac:graphicFrameMkLst>
        </pc:graphicFrameChg>
        <pc:graphicFrameChg chg="mod">
          <ac:chgData name="bakuru.vasu@outlook.com" userId="e87f3320efeb05aa" providerId="LiveId" clId="{5727996C-3E9A-476F-92BE-7B88FCB19D24}" dt="2023-01-13T10:52:30.844" v="166" actId="1076"/>
          <ac:graphicFrameMkLst>
            <pc:docMk/>
            <pc:sldMk cId="0" sldId="280"/>
            <ac:graphicFrameMk id="11" creationId="{00000000-0000-0000-0000-000000000000}"/>
          </ac:graphicFrameMkLst>
        </pc:graphicFrameChg>
      </pc:sldChg>
      <pc:sldChg chg="addSp delSp modSp mod">
        <pc:chgData name="bakuru.vasu@outlook.com" userId="e87f3320efeb05aa" providerId="LiveId" clId="{5727996C-3E9A-476F-92BE-7B88FCB19D24}" dt="2023-01-16T11:28:00.655" v="217"/>
        <pc:sldMkLst>
          <pc:docMk/>
          <pc:sldMk cId="4207555519" sldId="283"/>
        </pc:sldMkLst>
        <pc:spChg chg="add mod">
          <ac:chgData name="bakuru.vasu@outlook.com" userId="e87f3320efeb05aa" providerId="LiveId" clId="{5727996C-3E9A-476F-92BE-7B88FCB19D24}" dt="2023-01-16T09:17:31.281" v="195" actId="1076"/>
          <ac:spMkLst>
            <pc:docMk/>
            <pc:sldMk cId="4207555519" sldId="283"/>
            <ac:spMk id="4" creationId="{168E9F69-8B87-4704-D405-98B38033B1D4}"/>
          </ac:spMkLst>
        </pc:spChg>
        <pc:picChg chg="add del mod modCrop">
          <ac:chgData name="bakuru.vasu@outlook.com" userId="e87f3320efeb05aa" providerId="LiveId" clId="{5727996C-3E9A-476F-92BE-7B88FCB19D24}" dt="2023-01-16T11:28:00.655" v="217"/>
          <ac:picMkLst>
            <pc:docMk/>
            <pc:sldMk cId="4207555519" sldId="283"/>
            <ac:picMk id="2" creationId="{51E833B4-2F24-04EE-32B2-2E0BF3D3595A}"/>
          </ac:picMkLst>
        </pc:picChg>
        <pc:picChg chg="add del mod">
          <ac:chgData name="bakuru.vasu@outlook.com" userId="e87f3320efeb05aa" providerId="LiveId" clId="{5727996C-3E9A-476F-92BE-7B88FCB19D24}" dt="2023-01-16T11:27:58.133" v="212" actId="1076"/>
          <ac:picMkLst>
            <pc:docMk/>
            <pc:sldMk cId="4207555519" sldId="283"/>
            <ac:picMk id="3" creationId="{785D5C0D-C342-BE74-49BB-8DCA1B24B6E6}"/>
          </ac:picMkLst>
        </pc:picChg>
      </pc:sldChg>
      <pc:sldChg chg="addSp modSp new mod">
        <pc:chgData name="bakuru.vasu@outlook.com" userId="e87f3320efeb05aa" providerId="LiveId" clId="{5727996C-3E9A-476F-92BE-7B88FCB19D24}" dt="2023-01-16T09:17:41.400" v="196" actId="1076"/>
        <pc:sldMkLst>
          <pc:docMk/>
          <pc:sldMk cId="2889419637" sldId="284"/>
        </pc:sldMkLst>
        <pc:spChg chg="add mod">
          <ac:chgData name="bakuru.vasu@outlook.com" userId="e87f3320efeb05aa" providerId="LiveId" clId="{5727996C-3E9A-476F-92BE-7B88FCB19D24}" dt="2023-01-16T09:17:41.400" v="196" actId="1076"/>
          <ac:spMkLst>
            <pc:docMk/>
            <pc:sldMk cId="2889419637" sldId="284"/>
            <ac:spMk id="4" creationId="{04A18820-EF41-3D61-B633-035D697324FE}"/>
          </ac:spMkLst>
        </pc:spChg>
        <pc:picChg chg="add mod">
          <ac:chgData name="bakuru.vasu@outlook.com" userId="e87f3320efeb05aa" providerId="LiveId" clId="{5727996C-3E9A-476F-92BE-7B88FCB19D24}" dt="2023-01-10T10:09:42.706" v="22" actId="1076"/>
          <ac:picMkLst>
            <pc:docMk/>
            <pc:sldMk cId="2889419637" sldId="284"/>
            <ac:picMk id="2" creationId="{D571683E-3DF8-E59F-AA79-C82AB285D0A0}"/>
          </ac:picMkLst>
        </pc:picChg>
      </pc:sldChg>
      <pc:sldChg chg="addSp modSp add mod">
        <pc:chgData name="bakuru.vasu@outlook.com" userId="e87f3320efeb05aa" providerId="LiveId" clId="{5727996C-3E9A-476F-92BE-7B88FCB19D24}" dt="2023-01-16T11:28:01.051" v="218" actId="1076"/>
        <pc:sldMkLst>
          <pc:docMk/>
          <pc:sldMk cId="3069306753" sldId="285"/>
        </pc:sldMkLst>
        <pc:spChg chg="add mod">
          <ac:chgData name="bakuru.vasu@outlook.com" userId="e87f3320efeb05aa" providerId="LiveId" clId="{5727996C-3E9A-476F-92BE-7B88FCB19D24}" dt="2023-01-16T11:28:01.051" v="218" actId="1076"/>
          <ac:spMkLst>
            <pc:docMk/>
            <pc:sldMk cId="3069306753" sldId="285"/>
            <ac:spMk id="4" creationId="{5EF40A8D-4D51-A3F7-0CBB-4661FC6A052A}"/>
          </ac:spMkLst>
        </pc:spChg>
        <pc:picChg chg="add mod">
          <ac:chgData name="bakuru.vasu@outlook.com" userId="e87f3320efeb05aa" providerId="LiveId" clId="{5727996C-3E9A-476F-92BE-7B88FCB19D24}" dt="2023-01-10T10:12:44.947" v="77" actId="1076"/>
          <ac:picMkLst>
            <pc:docMk/>
            <pc:sldMk cId="3069306753" sldId="285"/>
            <ac:picMk id="2" creationId="{C78A1192-F752-DA0F-5CFA-08DE9BEEF5E6}"/>
          </ac:picMkLst>
        </pc:picChg>
      </pc:sldChg>
      <pc:sldChg chg="addSp delSp modSp add mod ord">
        <pc:chgData name="bakuru.vasu@outlook.com" userId="e87f3320efeb05aa" providerId="LiveId" clId="{5727996C-3E9A-476F-92BE-7B88FCB19D24}" dt="2023-01-13T12:19:23.912" v="185" actId="21"/>
        <pc:sldMkLst>
          <pc:docMk/>
          <pc:sldMk cId="2548721347" sldId="286"/>
        </pc:sldMkLst>
        <pc:spChg chg="add mod">
          <ac:chgData name="bakuru.vasu@outlook.com" userId="e87f3320efeb05aa" providerId="LiveId" clId="{5727996C-3E9A-476F-92BE-7B88FCB19D24}" dt="2023-01-13T12:19:20.339" v="183" actId="1076"/>
          <ac:spMkLst>
            <pc:docMk/>
            <pc:sldMk cId="2548721347" sldId="286"/>
            <ac:spMk id="3" creationId="{4F4DCD22-051A-644A-BB9E-803E5D792A06}"/>
          </ac:spMkLst>
        </pc:spChg>
        <pc:picChg chg="add del mod">
          <ac:chgData name="bakuru.vasu@outlook.com" userId="e87f3320efeb05aa" providerId="LiveId" clId="{5727996C-3E9A-476F-92BE-7B88FCB19D24}" dt="2023-01-13T12:19:17.875" v="182" actId="21"/>
          <ac:picMkLst>
            <pc:docMk/>
            <pc:sldMk cId="2548721347" sldId="286"/>
            <ac:picMk id="2" creationId="{E291384F-00DC-E471-BFA6-FBD8C4FC8F35}"/>
          </ac:picMkLst>
        </pc:picChg>
        <pc:picChg chg="add del mod modCrop">
          <ac:chgData name="bakuru.vasu@outlook.com" userId="e87f3320efeb05aa" providerId="LiveId" clId="{5727996C-3E9A-476F-92BE-7B88FCB19D24}" dt="2023-01-13T12:19:23.912" v="185" actId="21"/>
          <ac:picMkLst>
            <pc:docMk/>
            <pc:sldMk cId="2548721347" sldId="286"/>
            <ac:picMk id="5" creationId="{2FE99FF7-D857-C626-B560-6C159827BDAB}"/>
          </ac:picMkLst>
        </pc:picChg>
      </pc:sldChg>
      <pc:sldChg chg="addSp modSp new mod">
        <pc:chgData name="bakuru.vasu@outlook.com" userId="e87f3320efeb05aa" providerId="LiveId" clId="{5727996C-3E9A-476F-92BE-7B88FCB19D24}" dt="2023-01-13T12:19:09.578" v="180" actId="1076"/>
        <pc:sldMkLst>
          <pc:docMk/>
          <pc:sldMk cId="3883074255" sldId="287"/>
        </pc:sldMkLst>
        <pc:graphicFrameChg chg="add mod modGraphic">
          <ac:chgData name="bakuru.vasu@outlook.com" userId="e87f3320efeb05aa" providerId="LiveId" clId="{5727996C-3E9A-476F-92BE-7B88FCB19D24}" dt="2023-01-13T12:19:09.578" v="180" actId="1076"/>
          <ac:graphicFrameMkLst>
            <pc:docMk/>
            <pc:sldMk cId="3883074255" sldId="287"/>
            <ac:graphicFrameMk id="2" creationId="{02CC9FBF-5487-024E-375F-4AAE3CE36FB2}"/>
          </ac:graphicFrameMkLst>
        </pc:graphicFrameChg>
      </pc:sldChg>
      <pc:sldChg chg="addSp delSp modSp new mod">
        <pc:chgData name="bakuru.vasu@outlook.com" userId="e87f3320efeb05aa" providerId="LiveId" clId="{5727996C-3E9A-476F-92BE-7B88FCB19D24}" dt="2023-01-16T10:51:15.760" v="198" actId="478"/>
        <pc:sldMkLst>
          <pc:docMk/>
          <pc:sldMk cId="2227354023" sldId="288"/>
        </pc:sldMkLst>
        <pc:spChg chg="del">
          <ac:chgData name="bakuru.vasu@outlook.com" userId="e87f3320efeb05aa" providerId="LiveId" clId="{5727996C-3E9A-476F-92BE-7B88FCB19D24}" dt="2023-01-13T12:19:31.197" v="187" actId="478"/>
          <ac:spMkLst>
            <pc:docMk/>
            <pc:sldMk cId="2227354023" sldId="288"/>
            <ac:spMk id="2" creationId="{A04C3094-C03E-2B88-AD95-FAC84B76804D}"/>
          </ac:spMkLst>
        </pc:spChg>
        <pc:spChg chg="del">
          <ac:chgData name="bakuru.vasu@outlook.com" userId="e87f3320efeb05aa" providerId="LiveId" clId="{5727996C-3E9A-476F-92BE-7B88FCB19D24}" dt="2023-01-13T12:19:31.197" v="187" actId="478"/>
          <ac:spMkLst>
            <pc:docMk/>
            <pc:sldMk cId="2227354023" sldId="288"/>
            <ac:spMk id="3" creationId="{084BE28D-1C17-2CD6-2DE2-78F40C437038}"/>
          </ac:spMkLst>
        </pc:spChg>
        <pc:spChg chg="del">
          <ac:chgData name="bakuru.vasu@outlook.com" userId="e87f3320efeb05aa" providerId="LiveId" clId="{5727996C-3E9A-476F-92BE-7B88FCB19D24}" dt="2023-01-13T12:19:31.197" v="187" actId="478"/>
          <ac:spMkLst>
            <pc:docMk/>
            <pc:sldMk cId="2227354023" sldId="288"/>
            <ac:spMk id="4" creationId="{603A54BD-4DDC-7553-4CB1-CA825C951279}"/>
          </ac:spMkLst>
        </pc:spChg>
        <pc:picChg chg="add del mod">
          <ac:chgData name="bakuru.vasu@outlook.com" userId="e87f3320efeb05aa" providerId="LiveId" clId="{5727996C-3E9A-476F-92BE-7B88FCB19D24}" dt="2023-01-16T10:51:15.760" v="198" actId="478"/>
          <ac:picMkLst>
            <pc:docMk/>
            <pc:sldMk cId="2227354023" sldId="288"/>
            <ac:picMk id="5" creationId="{0C36764C-19EF-5371-7340-E013D9E5534E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Projects\Jayaramulu\solketal%20GR-SO3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  <c:spPr>
        <a:noFill/>
        <a:ln w="25400">
          <a:noFill/>
        </a:ln>
      </c:spPr>
    </c:sideWall>
    <c:backWall>
      <c:thickness val="0"/>
      <c:spPr>
        <a:noFill/>
        <a:ln w="25400">
          <a:noFill/>
        </a:ln>
      </c:spPr>
    </c:backWall>
    <c:plotArea>
      <c:layout/>
      <c:bar3DChart>
        <c:barDir val="col"/>
        <c:grouping val="stack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0-1105-43AB-A96B-F19C62685FF2}"/>
              </c:ext>
            </c:extLst>
          </c:dPt>
          <c:dPt>
            <c:idx val="1"/>
            <c:invertIfNegative val="0"/>
            <c:bubble3D val="0"/>
            <c:spPr>
              <a:solidFill>
                <a:srgbClr val="DC12D2"/>
              </a:solidFill>
            </c:spPr>
            <c:extLst>
              <c:ext xmlns:c16="http://schemas.microsoft.com/office/drawing/2014/chart" uri="{C3380CC4-5D6E-409C-BE32-E72D297353CC}">
                <c16:uniqueId val="{00000001-1105-43AB-A96B-F19C62685FF2}"/>
              </c:ext>
            </c:extLst>
          </c:dPt>
          <c:dPt>
            <c:idx val="2"/>
            <c:invertIfNegative val="0"/>
            <c:bubble3D val="0"/>
            <c:spPr>
              <a:solidFill>
                <a:srgbClr val="00823B"/>
              </a:solidFill>
            </c:spPr>
            <c:extLst>
              <c:ext xmlns:c16="http://schemas.microsoft.com/office/drawing/2014/chart" uri="{C3380CC4-5D6E-409C-BE32-E72D297353CC}">
                <c16:uniqueId val="{00000002-1105-43AB-A96B-F19C62685FF2}"/>
              </c:ext>
            </c:extLst>
          </c:dPt>
          <c:cat>
            <c:strRef>
              <c:f>Sheet1!$D$6:$D$8</c:f>
              <c:strCache>
                <c:ptCount val="3"/>
                <c:pt idx="0">
                  <c:v>Glycerol conv.(%)</c:v>
                </c:pt>
                <c:pt idx="1">
                  <c:v>Solketal sel.(%)</c:v>
                </c:pt>
                <c:pt idx="2">
                  <c:v>Acetal sel.(%)</c:v>
                </c:pt>
              </c:strCache>
            </c:strRef>
          </c:cat>
          <c:val>
            <c:numRef>
              <c:f>Sheet1!$E$6:$E$8</c:f>
              <c:numCache>
                <c:formatCode>General</c:formatCode>
                <c:ptCount val="3"/>
                <c:pt idx="0">
                  <c:v>96.5</c:v>
                </c:pt>
                <c:pt idx="1">
                  <c:v>96.8</c:v>
                </c:pt>
                <c:pt idx="2">
                  <c:v>3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105-43AB-A96B-F19C62685F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83890560"/>
        <c:axId val="83892096"/>
        <c:axId val="0"/>
      </c:bar3DChart>
      <c:catAx>
        <c:axId val="838905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800" b="1"/>
            </a:pPr>
            <a:endParaRPr lang="en-US"/>
          </a:p>
        </c:txPr>
        <c:crossAx val="83892096"/>
        <c:crosses val="autoZero"/>
        <c:auto val="1"/>
        <c:lblAlgn val="ctr"/>
        <c:lblOffset val="100"/>
        <c:noMultiLvlLbl val="0"/>
      </c:catAx>
      <c:valAx>
        <c:axId val="83892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800" b="1"/>
            </a:pPr>
            <a:endParaRPr lang="en-US"/>
          </a:p>
        </c:txPr>
        <c:crossAx val="838905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44133C-D832-45F5-B8BF-DE3D12A51423}" type="datetimeFigureOut">
              <a:rPr lang="en-US" smtClean="0"/>
              <a:pPr/>
              <a:t>20-Jan-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0E68D8-A639-403B-8FE3-5205E23C33F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4692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581409-5608-4D1B-9789-6374E0CEF3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BFD88DE-1EF6-4A70-ADC9-82464D49CB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B0E2E7-07FC-4DFD-BAE3-E1B16E8AF3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7FAA7-AFB7-4479-8408-A4A4E85310FA}" type="datetimeFigureOut">
              <a:rPr lang="en-GB" smtClean="0"/>
              <a:pPr/>
              <a:t>20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3D0B55-864A-4F91-A417-C6A5FEC70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839DE1-CD65-4CBF-956D-AD1E79341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AEEF-DD3A-4A3E-9E8C-68AB0925A96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3181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CB5769-E668-4E6B-B82A-56B88930AF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83F4D3-40B4-478B-9429-10BD101AA2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D722BC-EA53-45A5-8C73-9A3484B34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7FAA7-AFB7-4479-8408-A4A4E85310FA}" type="datetimeFigureOut">
              <a:rPr lang="en-GB" smtClean="0"/>
              <a:pPr/>
              <a:t>20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911359-4DF7-4DB5-8D81-A3A864E864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6F8212-3489-4FDE-A5B9-67D3AD14A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AEEF-DD3A-4A3E-9E8C-68AB0925A96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2803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7B6BFE8-74C2-474F-A933-BB6EA611AC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785202-FB02-41CF-9AE1-405D041261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106808-AA8F-42BE-BAF8-7F46BF77EF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7FAA7-AFB7-4479-8408-A4A4E85310FA}" type="datetimeFigureOut">
              <a:rPr lang="en-GB" smtClean="0"/>
              <a:pPr/>
              <a:t>20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6CB01B-71D6-450F-86B9-FCA372E00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867A16-1996-44D2-BE46-ED6997E2B9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AEEF-DD3A-4A3E-9E8C-68AB0925A96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3560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DDCDBF-12AD-441A-AD3F-E86768B435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F87CB3-9E87-4936-B86B-CB1C336A05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8512E7-9497-47A0-8C14-C03F5D0D9A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7FAA7-AFB7-4479-8408-A4A4E85310FA}" type="datetimeFigureOut">
              <a:rPr lang="en-GB" smtClean="0"/>
              <a:pPr/>
              <a:t>20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1850-7347-4079-AABF-39B3A123D9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632A89-D71A-44F9-B6BF-9B08404C8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AEEF-DD3A-4A3E-9E8C-68AB0925A96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1074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FA49B3-34E5-428E-A507-3F68D59922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3875B6-2301-4DCE-ACC6-6F0FA865CD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5F6D31-C34D-4217-BE67-04C3FD9A9B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7FAA7-AFB7-4479-8408-A4A4E85310FA}" type="datetimeFigureOut">
              <a:rPr lang="en-GB" smtClean="0"/>
              <a:pPr/>
              <a:t>20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BB8980-D065-43A2-A816-94477F62F2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F7A1DA-AE6F-4A5B-AB82-13826EB3D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AEEF-DD3A-4A3E-9E8C-68AB0925A96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0257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4138DA-B77F-4FC4-B5EF-F5FCD81F93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384CC3-D766-46C0-945E-1BD03E1205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240723-B514-4341-BAD8-587D9489B1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DAC220-6E9B-4BC3-850B-430655F9D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7FAA7-AFB7-4479-8408-A4A4E85310FA}" type="datetimeFigureOut">
              <a:rPr lang="en-GB" smtClean="0"/>
              <a:pPr/>
              <a:t>20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D3E838-05E3-4675-ACA8-C501154A1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CED742-2A46-4142-94C6-CA125632E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AEEF-DD3A-4A3E-9E8C-68AB0925A96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5746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F9C8E7-9FB6-48F9-AE23-372FE44376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C7E0EA-4273-402E-BBD1-E3D0A4E957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67A7C4-9599-4B87-8D0C-3E36111EE3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B4B29C-8866-4CA3-BB32-BFEB757408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9037DD-469B-47D2-830C-12F5A727FF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102E1C-AAF0-4146-82E7-4712161AF4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7FAA7-AFB7-4479-8408-A4A4E85310FA}" type="datetimeFigureOut">
              <a:rPr lang="en-GB" smtClean="0"/>
              <a:pPr/>
              <a:t>20/01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246B2A-0914-472F-82A3-66B789A6B8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F5F10B-08D0-42F2-8A6E-FE3ACAEF2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AEEF-DD3A-4A3E-9E8C-68AB0925A96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92464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6219EC-B259-4A21-9DE5-E899950E29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B0F7F09-9244-4871-8F08-4E4C1B931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7FAA7-AFB7-4479-8408-A4A4E85310FA}" type="datetimeFigureOut">
              <a:rPr lang="en-GB" smtClean="0"/>
              <a:pPr/>
              <a:t>20/0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DB0E64E-744F-40EE-9939-3A0664609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A2D84A-D949-43E7-8B43-7410A505B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AEEF-DD3A-4A3E-9E8C-68AB0925A96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9121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7952FD9-84C8-4A42-9170-56203C631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7FAA7-AFB7-4479-8408-A4A4E85310FA}" type="datetimeFigureOut">
              <a:rPr lang="en-GB" smtClean="0"/>
              <a:pPr/>
              <a:t>20/0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EE9D1D8-CA2D-433C-90E7-D48FC3D656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CFF9F2-BC84-49AC-BDDD-BD2BEDC00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AEEF-DD3A-4A3E-9E8C-68AB0925A96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8138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6AE2A5-38CF-4AA6-9605-4BCF4A4EBE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C678CE-B489-40A2-BA69-74BB5D4D89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2B8921-B19C-402D-8556-92B77E9DBD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0851D1-59AB-4BE1-B0BC-60A93C55B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7FAA7-AFB7-4479-8408-A4A4E85310FA}" type="datetimeFigureOut">
              <a:rPr lang="en-GB" smtClean="0"/>
              <a:pPr/>
              <a:t>20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14E246-5448-44FF-B700-4C7CF2F6B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D69331-8828-4489-92E0-FC6523E7A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AEEF-DD3A-4A3E-9E8C-68AB0925A96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0066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1F8C70-0273-4802-BC22-7342FE683D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D1B6D61-E04D-4672-9066-67D78295A7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A31624-2B30-44B8-96C8-822F0DBE6F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1777EF-8CCB-4E71-8EAA-8CA07EC9A5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7FAA7-AFB7-4479-8408-A4A4E85310FA}" type="datetimeFigureOut">
              <a:rPr lang="en-GB" smtClean="0"/>
              <a:pPr/>
              <a:t>20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11F32A-3D42-46BE-8668-04069B968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76DE08-DBF4-4E92-98A3-48BBD21286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AEEF-DD3A-4A3E-9E8C-68AB0925A96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0625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1516179-A501-4248-A0AC-D8A97AD295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34FF9A-623C-4C42-941E-B68F451DC5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C4C622-215D-43F6-BEDF-9C5D7560B9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7FAA7-AFB7-4479-8408-A4A4E85310FA}" type="datetimeFigureOut">
              <a:rPr lang="en-GB" smtClean="0"/>
              <a:pPr/>
              <a:t>20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FA20C1-CC39-4258-B7B5-A2D51077CB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F410BD-BB4F-465F-8B5A-9C15E1EF94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E0AEEF-DD3A-4A3E-9E8C-68AB0925A96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20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3"/>
          <p:cNvSpPr>
            <a:spLocks noChangeArrowheads="1"/>
          </p:cNvSpPr>
          <p:nvPr/>
        </p:nvSpPr>
        <p:spPr bwMode="auto">
          <a:xfrm>
            <a:off x="611131" y="1222605"/>
            <a:ext cx="5554641" cy="17543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Reaction conditions: </a:t>
            </a:r>
            <a:r>
              <a:rPr kumimoji="0" 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Glycerol = 1.0 g, Acetone = 2.52g, Glycerol(G): acetone = 1:4, catalyst (G-ASA)= 0.5 wt% (referred to </a:t>
            </a:r>
            <a:r>
              <a:rPr lang="en-US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Substrate</a:t>
            </a:r>
            <a:r>
              <a:rPr kumimoji="0" 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), reaction carried at R.T for 1h. Finally, MeOH was added, and the product was separated from the catalyst and analyzed using a gas chromatogram(GC).  </a:t>
            </a:r>
            <a:endParaRPr kumimoji="0" 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2" name="Group 21"/>
          <p:cNvGrpSpPr/>
          <p:nvPr/>
        </p:nvGrpSpPr>
        <p:grpSpPr>
          <a:xfrm>
            <a:off x="2144926" y="3750087"/>
            <a:ext cx="7217250" cy="3066688"/>
            <a:chOff x="1746911" y="3234519"/>
            <a:chExt cx="7642748" cy="3111690"/>
          </a:xfrm>
        </p:grpSpPr>
        <p:pic>
          <p:nvPicPr>
            <p:cNvPr id="6" name="Picture 5"/>
            <p:cNvPicPr/>
            <p:nvPr/>
          </p:nvPicPr>
          <p:blipFill>
            <a:blip r:embed="rId2" cstate="print"/>
            <a:srcRect l="25209" t="32146" r="4026" b="27804"/>
            <a:stretch>
              <a:fillRect/>
            </a:stretch>
          </p:blipFill>
          <p:spPr bwMode="auto">
            <a:xfrm>
              <a:off x="1746911" y="3234519"/>
              <a:ext cx="7642748" cy="31116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" name="TextBox 8"/>
            <p:cNvSpPr txBox="1"/>
            <p:nvPr/>
          </p:nvSpPr>
          <p:spPr>
            <a:xfrm>
              <a:off x="3835021" y="3780430"/>
              <a:ext cx="9391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002060"/>
                  </a:solidFill>
                </a:rPr>
                <a:t>Solketal</a:t>
              </a: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V="1">
              <a:off x="3698543" y="4080682"/>
              <a:ext cx="272956" cy="300249"/>
            </a:xfrm>
            <a:prstGeom prst="straightConnector1">
              <a:avLst/>
            </a:prstGeom>
            <a:ln w="28575">
              <a:solidFill>
                <a:schemeClr val="bg2">
                  <a:lumMod val="1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 flipV="1">
              <a:off x="4558352" y="5379494"/>
              <a:ext cx="398060" cy="229736"/>
            </a:xfrm>
            <a:prstGeom prst="straightConnector1">
              <a:avLst/>
            </a:prstGeom>
            <a:ln w="28575">
              <a:solidFill>
                <a:schemeClr val="bg2">
                  <a:lumMod val="1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4929116" y="5133834"/>
              <a:ext cx="7819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002060"/>
                  </a:solidFill>
                </a:rPr>
                <a:t>Acetal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726907" y="5038299"/>
              <a:ext cx="9643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002060"/>
                  </a:solidFill>
                </a:rPr>
                <a:t>Glycerol</a:t>
              </a:r>
            </a:p>
          </p:txBody>
        </p:sp>
        <p:cxnSp>
          <p:nvCxnSpPr>
            <p:cNvPr id="16" name="Straight Arrow Connector 15"/>
            <p:cNvCxnSpPr/>
            <p:nvPr/>
          </p:nvCxnSpPr>
          <p:spPr>
            <a:xfrm flipV="1">
              <a:off x="7492621" y="5322627"/>
              <a:ext cx="300251" cy="313899"/>
            </a:xfrm>
            <a:prstGeom prst="straightConnector1">
              <a:avLst/>
            </a:prstGeom>
            <a:ln w="28575">
              <a:solidFill>
                <a:schemeClr val="bg2">
                  <a:lumMod val="1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oup 27"/>
          <p:cNvGrpSpPr/>
          <p:nvPr/>
        </p:nvGrpSpPr>
        <p:grpSpPr>
          <a:xfrm>
            <a:off x="6728070" y="503612"/>
            <a:ext cx="4572000" cy="2743621"/>
            <a:chOff x="6525905" y="855976"/>
            <a:chExt cx="4572000" cy="2743621"/>
          </a:xfrm>
        </p:grpSpPr>
        <p:graphicFrame>
          <p:nvGraphicFramePr>
            <p:cNvPr id="21" name="Chart 20"/>
            <p:cNvGraphicFramePr/>
            <p:nvPr/>
          </p:nvGraphicFramePr>
          <p:xfrm>
            <a:off x="6525905" y="856397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4" name="Rectangle 23"/>
            <p:cNvSpPr/>
            <p:nvPr/>
          </p:nvSpPr>
          <p:spPr>
            <a:xfrm>
              <a:off x="7764561" y="855976"/>
              <a:ext cx="59343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/>
                <a:t>96.5</a:t>
              </a: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8801792" y="924214"/>
              <a:ext cx="59343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/>
                <a:t>96.8</a:t>
              </a: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9870236" y="2234400"/>
              <a:ext cx="47641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/>
                <a:t>3.2</a:t>
              </a:r>
            </a:p>
          </p:txBody>
        </p:sp>
      </p:grpSp>
      <p:sp>
        <p:nvSpPr>
          <p:cNvPr id="27" name="Rectangle 26"/>
          <p:cNvSpPr/>
          <p:nvPr/>
        </p:nvSpPr>
        <p:spPr>
          <a:xfrm>
            <a:off x="852350" y="726257"/>
            <a:ext cx="504420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solidFill>
                  <a:srgbClr val="7B238D"/>
                </a:solidFill>
              </a:rPr>
              <a:t>Solketal synthesis under following conditions: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5734812" y="3349977"/>
            <a:ext cx="48943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Gas chromatogram data for product analysis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2CC9FBF-5487-024E-375F-4AAE3CE36F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5053828"/>
              </p:ext>
            </p:extLst>
          </p:nvPr>
        </p:nvGraphicFramePr>
        <p:xfrm>
          <a:off x="579911" y="1160547"/>
          <a:ext cx="11032177" cy="1229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0214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9704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36655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16643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52852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Molar ratio b/w glycerol to acetone</a:t>
                      </a:r>
                      <a:endParaRPr lang="en-US" sz="2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Glycerol con.(%)</a:t>
                      </a:r>
                      <a:endParaRPr lang="en-US" sz="20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Solketal sel.(%)</a:t>
                      </a:r>
                      <a:endParaRPr lang="en-US" sz="2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Acetal sel.(%)</a:t>
                      </a:r>
                      <a:endParaRPr lang="en-US" sz="2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31922"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1: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96.5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(97 % in paper)</a:t>
                      </a:r>
                      <a:endParaRPr lang="en-US" sz="2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96.8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(97 % in paper)</a:t>
                      </a:r>
                      <a:endParaRPr lang="en-US" sz="2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3.2</a:t>
                      </a:r>
                      <a:endParaRPr lang="en-US" sz="2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9" name="Picture 8" descr="A picture containing diagram&#10;&#10;Description automatically generated">
            <a:extLst>
              <a:ext uri="{FF2B5EF4-FFF2-40B4-BE49-F238E27FC236}">
                <a16:creationId xmlns:a16="http://schemas.microsoft.com/office/drawing/2014/main" id="{8F2C38E1-DE23-9AA7-6A03-85261C21CD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19" t="17929" r="14696" b="51081"/>
          <a:stretch/>
        </p:blipFill>
        <p:spPr>
          <a:xfrm>
            <a:off x="328056" y="2627769"/>
            <a:ext cx="11612088" cy="306968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079C04F-950A-7191-2D27-7E9E36258C9D}"/>
              </a:ext>
            </a:extLst>
          </p:cNvPr>
          <p:cNvSpPr txBox="1"/>
          <p:nvPr/>
        </p:nvSpPr>
        <p:spPr>
          <a:xfrm>
            <a:off x="4849451" y="230795"/>
            <a:ext cx="29234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i="1" u="sng" dirty="0">
                <a:solidFill>
                  <a:srgbClr val="7B238D"/>
                </a:solidFill>
              </a:rPr>
              <a:t>molar ratio study</a:t>
            </a:r>
          </a:p>
        </p:txBody>
      </p:sp>
      <p:sp>
        <p:nvSpPr>
          <p:cNvPr id="12" name="Rectangle 3">
            <a:extLst>
              <a:ext uri="{FF2B5EF4-FFF2-40B4-BE49-F238E27FC236}">
                <a16:creationId xmlns:a16="http://schemas.microsoft.com/office/drawing/2014/main" id="{203EBA80-B30F-3964-EA1B-860EC2B3AD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9911" y="5980874"/>
            <a:ext cx="10921903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Reaction conditions: </a:t>
            </a:r>
            <a:r>
              <a:rPr kumimoji="0" lang="en-US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1:4 mole ratio between </a:t>
            </a:r>
            <a:r>
              <a:rPr kumimoji="0" 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Glycerol to Acetone , </a:t>
            </a:r>
            <a:r>
              <a:rPr lang="en-US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Catalyst (G-ASA)-0.5 wt% (referred to substrate), reaction </a:t>
            </a:r>
            <a:r>
              <a:rPr kumimoji="0" 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carried at R.T for 1h. </a:t>
            </a:r>
            <a:endParaRPr kumimoji="0" 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30742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&#10;&#10;Description automatically generated with low confidence">
            <a:extLst>
              <a:ext uri="{FF2B5EF4-FFF2-40B4-BE49-F238E27FC236}">
                <a16:creationId xmlns:a16="http://schemas.microsoft.com/office/drawing/2014/main" id="{3D9FA295-7C05-9A28-2D81-B367CB9B48E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39" t="14718" r="14414" b="46321"/>
          <a:stretch/>
        </p:blipFill>
        <p:spPr>
          <a:xfrm>
            <a:off x="431570" y="2363258"/>
            <a:ext cx="11405059" cy="3491346"/>
          </a:xfrm>
          <a:prstGeom prst="rect">
            <a:avLst/>
          </a:prstGeom>
        </p:spPr>
      </p:pic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164A676-A4CC-2E2F-5E46-1B42C1E7EA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0371073"/>
              </p:ext>
            </p:extLst>
          </p:nvPr>
        </p:nvGraphicFramePr>
        <p:xfrm>
          <a:off x="579910" y="908394"/>
          <a:ext cx="11032177" cy="1229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0214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9704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36655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16643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52852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Molar ratio b/w glycerol to acetone</a:t>
                      </a:r>
                      <a:endParaRPr lang="en-US" sz="2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Glycerol con.(%)</a:t>
                      </a:r>
                      <a:endParaRPr lang="en-US" sz="20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Solketal sel.(%)</a:t>
                      </a:r>
                      <a:endParaRPr lang="en-US" sz="2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Acetal sel.(%)</a:t>
                      </a:r>
                      <a:endParaRPr lang="en-US" sz="2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31922"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1: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&gt; 98.9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(100 % in paper)</a:t>
                      </a:r>
                      <a:endParaRPr lang="en-US" sz="2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96.3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(96 % in paper)</a:t>
                      </a:r>
                      <a:endParaRPr lang="en-US" sz="2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3.7</a:t>
                      </a:r>
                      <a:endParaRPr lang="en-US" sz="2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7" name="Rectangle 3">
            <a:extLst>
              <a:ext uri="{FF2B5EF4-FFF2-40B4-BE49-F238E27FC236}">
                <a16:creationId xmlns:a16="http://schemas.microsoft.com/office/drawing/2014/main" id="{A93A04ED-ECAA-D54D-3105-FD8AAC58C0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9910" y="5949606"/>
            <a:ext cx="10921903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Reaction conditions: </a:t>
            </a:r>
            <a:r>
              <a:rPr kumimoji="0" lang="en-US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1:2 mole ratio between </a:t>
            </a:r>
            <a:r>
              <a:rPr kumimoji="0" 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Glycerol to Acetone , </a:t>
            </a:r>
            <a:r>
              <a:rPr lang="en-US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Catalyst (G-ASA)-0.5 wt% (referred to substrate), reaction </a:t>
            </a:r>
            <a:r>
              <a:rPr kumimoji="0" 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carried at R.T for 1h. </a:t>
            </a:r>
            <a:endParaRPr kumimoji="0" 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73540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85D5C0D-C342-BE74-49BB-8DCA1B24B6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7189" y="775334"/>
            <a:ext cx="9127496" cy="530733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68E9F69-8B87-4704-D405-98B38033B1D4}"/>
              </a:ext>
            </a:extLst>
          </p:cNvPr>
          <p:cNvSpPr txBox="1"/>
          <p:nvPr/>
        </p:nvSpPr>
        <p:spPr>
          <a:xfrm>
            <a:off x="1538243" y="344447"/>
            <a:ext cx="8263783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cs-CZ" sz="2200" b="1" dirty="0" smtClean="0">
                <a:solidFill>
                  <a:srgbClr val="0070C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The position of unreacted gl</a:t>
            </a:r>
            <a:r>
              <a:rPr lang="en-US" sz="2200" b="1" dirty="0" smtClean="0">
                <a:solidFill>
                  <a:srgbClr val="0070C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y</a:t>
            </a:r>
            <a:r>
              <a:rPr lang="cs-CZ" sz="2200" b="1" dirty="0" smtClean="0">
                <a:solidFill>
                  <a:srgbClr val="0070C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erol is </a:t>
            </a:r>
            <a:r>
              <a:rPr lang="en-US" sz="2200" b="1" dirty="0" smtClean="0">
                <a:solidFill>
                  <a:srgbClr val="0070C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available </a:t>
            </a:r>
            <a:r>
              <a:rPr lang="cs-CZ" sz="2200" b="1" dirty="0" smtClean="0">
                <a:solidFill>
                  <a:srgbClr val="0070C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in this GC gra</a:t>
            </a:r>
            <a:r>
              <a:rPr lang="en-US" sz="2200" b="1" dirty="0" smtClean="0">
                <a:solidFill>
                  <a:srgbClr val="0070C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p</a:t>
            </a:r>
            <a:r>
              <a:rPr lang="cs-CZ" sz="2200" b="1" dirty="0" smtClean="0">
                <a:solidFill>
                  <a:srgbClr val="0070C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h</a:t>
            </a:r>
            <a:endParaRPr lang="en-US" sz="2200" b="1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7555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919</TotalTime>
  <Words>217</Words>
  <Application>Microsoft Office PowerPoint</Application>
  <PresentationFormat>Widescreen</PresentationFormat>
  <Paragraphs>3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Cordia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anillin Hydrogenation</dc:title>
  <dc:creator>Deljo Davis</dc:creator>
  <cp:lastModifiedBy>Bakandritsos Aristeidis</cp:lastModifiedBy>
  <cp:revision>930</cp:revision>
  <dcterms:created xsi:type="dcterms:W3CDTF">2018-06-26T19:07:57Z</dcterms:created>
  <dcterms:modified xsi:type="dcterms:W3CDTF">2023-01-20T15:18:29Z</dcterms:modified>
</cp:coreProperties>
</file>